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73B6CB-C6EF-49E9-B897-87B2158971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6A8C5-A59A-4D26-884F-B2691F2AA6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CA6E0-3280-4C7A-9D4F-EAC50DED65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9815E-154B-45C7-9632-956A9DD9C0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F59B0-14FB-4F93-9281-95D9CD0377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7A8A4-3BB1-49A0-B1AC-D4691422E1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FE57E-B878-4A11-8E46-775190DA46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94D54-8492-4A82-81B4-004DDE0E8C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1A1E2-8903-45F0-858A-AA8C9CA3C3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95D0A-7ED1-4178-957B-76DBF1225E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68428-DB9A-4EF3-97DA-7B7526B888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119ED-A2DE-4C13-A29E-5D44CDFFB9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A52C5C-3893-4D37-BEA6-B14E96DB423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Fig1"/>
          <p:cNvPicPr/>
          <p:nvPr/>
        </p:nvPicPr>
        <p:blipFill>
          <a:blip r:embed="rId1"/>
          <a:stretch/>
        </p:blipFill>
        <p:spPr>
          <a:xfrm>
            <a:off x="914400" y="533520"/>
            <a:ext cx="7238880" cy="50767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5"/>
          <p:cNvSpPr/>
          <p:nvPr/>
        </p:nvSpPr>
        <p:spPr>
          <a:xfrm>
            <a:off x="669960" y="5751360"/>
            <a:ext cx="7483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dditional file 1.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Xanthomonas oryzae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pv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oryzae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induced disease symptoms in adult rice plants. A. Susceptible IR24. B. Resistant IET85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sampa</dc:creator>
  <dc:description/>
  <dc:language>en-US</dc:language>
  <cp:lastModifiedBy>Prof. Sampa Das</cp:lastModifiedBy>
  <dcterms:modified xsi:type="dcterms:W3CDTF">2011-12-19T09:35:24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